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923213" cy="63007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73320" y="685440"/>
            <a:ext cx="431136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FD54BF-4870-4F84-A374-BEF888EF08DA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1273320" y="685800"/>
            <a:ext cx="4311360" cy="342900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85800" y="4344840"/>
            <a:ext cx="548640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Additional file 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E4C6B-7DC6-4C02-8761-1A93210E99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71294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96720" y="3641040"/>
            <a:ext cx="71294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0679B-E272-4ACC-B025-F5A00DF7C3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050000" y="146952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96720" y="364104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050000" y="364104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FAC4F-6B90-4F92-83DA-7CBC1BD748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229536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07280" y="1469520"/>
            <a:ext cx="229536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217840" y="1469520"/>
            <a:ext cx="229536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96720" y="3641040"/>
            <a:ext cx="229536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07280" y="3641040"/>
            <a:ext cx="229536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217840" y="3641040"/>
            <a:ext cx="229536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03758-8AE4-457E-B0F9-113DDE40E4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96720" y="1469520"/>
            <a:ext cx="7129440" cy="415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22866-314B-41B4-9532-456BE8B160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7129440" cy="415764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66B31-5685-4DAD-8333-79F28FA3DB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3479040" cy="415764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050000" y="1469520"/>
            <a:ext cx="3479040" cy="415764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AD8CE-E045-453F-993D-347CD041C1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14D9F-18A2-4AC0-8AD4-61C7E13255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96720" y="252000"/>
            <a:ext cx="7129440" cy="486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5AB1B-1B6A-4AE0-9248-71BD235FAE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050000" y="1469520"/>
            <a:ext cx="3479040" cy="415764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96720" y="364104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27B31-A757-4704-BB9C-DC30D476E8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3479040" cy="415764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050000" y="146952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050000" y="364104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E364B-6A2E-4444-9740-D6C3C6E130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96720" y="146952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050000" y="1469520"/>
            <a:ext cx="34790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96720" y="3641040"/>
            <a:ext cx="7129440" cy="198288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CD2D24-D101-4D72-B27A-AD6818CF70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96720" y="252000"/>
            <a:ext cx="7129440" cy="104940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ctr">
            <a:noAutofit/>
          </a:bodyPr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96720" y="1469520"/>
            <a:ext cx="7129440" cy="415764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rmAutofit/>
          </a:bodyPr>
          <a:p>
            <a:pPr marL="304920" indent="-30492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0240" indent="-2538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5920" indent="-2030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2360" indent="-2030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20304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20304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20304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96360" y="5736960"/>
            <a:ext cx="1847880" cy="43812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Autofit/>
          </a:bodyPr>
          <a:lstStyle>
            <a:lvl1pPr indent="0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06480" y="5736960"/>
            <a:ext cx="2508120" cy="43812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Autofit/>
          </a:bodyPr>
          <a:lstStyle>
            <a:lvl1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676480" y="5736960"/>
            <a:ext cx="1849320" cy="438120"/>
          </a:xfrm>
          <a:prstGeom prst="rect">
            <a:avLst/>
          </a:prstGeom>
          <a:noFill/>
          <a:ln w="0">
            <a:noFill/>
          </a:ln>
        </p:spPr>
        <p:txBody>
          <a:bodyPr lIns="81360" rIns="81360" tIns="40680" bIns="40680" anchor="t">
            <a:noAutofit/>
          </a:bodyPr>
          <a:lstStyle>
            <a:lvl1pPr indent="0" algn="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812880"/>
                <a:tab algn="l" pos="1625760"/>
                <a:tab algn="l" pos="2438280"/>
                <a:tab algn="l" pos="3251160"/>
                <a:tab algn="l" pos="4064040"/>
                <a:tab algn="l" pos="4876920"/>
                <a:tab algn="l" pos="5689440"/>
                <a:tab algn="l" pos="6502320"/>
                <a:tab algn="l" pos="7315200"/>
                <a:tab algn="l" pos="8128080"/>
                <a:tab algn="l" pos="8940960"/>
                <a:tab algn="l" pos="9753480"/>
                <a:tab algn="l" pos="10566360"/>
              </a:tabLst>
            </a:pPr>
            <a:fld id="{AC7DBE4B-3908-4E17-9A75-667BA2F262D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417600" y="846000"/>
          <a:ext cx="7188120" cy="49914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17600" y="846000"/>
                    <a:ext cx="7188120" cy="4991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"/>
          <p:cNvSpPr/>
          <p:nvPr/>
        </p:nvSpPr>
        <p:spPr>
          <a:xfrm>
            <a:off x="429120" y="5270400"/>
            <a:ext cx="7474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Luciferase expression from transient transfection of bicistronic plasmids carrying the polio IRES , the BVDV 5‘ UTR 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the complete BVDV IRES , a plasmid with inhibitory stemloop upstream the first cistron and a bicistronic plasmi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without IRES.  Translation mediated  by polioIRES served as standard for comparis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8320" y="446040"/>
            <a:ext cx="498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Translation efficiency mediated by the BVDV IRES in different cell lines</a:t>
            </a:r>
            <a:r>
              <a:rPr b="1" lang="de-DE" sz="12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23T16:52:33Z</dcterms:created>
  <dc:creator>mwi</dc:creator>
  <dc:description/>
  <dc:language>en-US</dc:language>
  <cp:lastModifiedBy>mwi</cp:lastModifiedBy>
  <dcterms:modified xsi:type="dcterms:W3CDTF">2007-11-05T15:54:52Z</dcterms:modified>
  <cp:revision>3</cp:revision>
  <dc:subject/>
  <dc:title>Folie 1</dc:title>
</cp:coreProperties>
</file>